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57628-18A5-4E65-B966-D6A3071E32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795D5-8A68-4CE8-82E6-9B7F662B0A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2D7AC-CA60-407E-8299-B27854ADE9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0B9BA2-9804-468B-998B-DF26287E9F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5F862-9468-4859-AB35-6A8B286766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1127DE-754B-4803-B755-38B90FCE4C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600A4-14AA-4DB5-852D-7D32EBBF7E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63287-C5F5-4006-87E9-2D925BC7FE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85BA93-4038-45A5-A56A-A7AA89EF50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4B3BC-0FE6-43FD-931C-77FEC050BE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F1D5D7-8274-4545-BCF5-B799E57953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F1657-D229-4045-977C-C36A29D877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8DF23D-19F2-4C71-8605-493D889DB28D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0" y="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1" descr="Figure 3 S1"/>
          <p:cNvPicPr/>
          <p:nvPr/>
        </p:nvPicPr>
        <p:blipFill>
          <a:blip r:embed="rId1"/>
          <a:stretch/>
        </p:blipFill>
        <p:spPr>
          <a:xfrm>
            <a:off x="609480" y="533520"/>
            <a:ext cx="7772400" cy="537192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3"/>
          <p:cNvSpPr/>
          <p:nvPr/>
        </p:nvSpPr>
        <p:spPr>
          <a:xfrm>
            <a:off x="0" y="582948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4"/>
          <p:cNvSpPr/>
          <p:nvPr/>
        </p:nvSpPr>
        <p:spPr>
          <a:xfrm>
            <a:off x="304920" y="6095160"/>
            <a:ext cx="8610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S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Relative Water Content of three transgenic lines and WT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Under various levels of PEG (A) and NaCl (B) with increasing days of stress exposure (refer to Figure 1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24T18:09:22Z</dcterms:created>
  <dc:creator>Dr. Radhakrishnan</dc:creator>
  <dc:description/>
  <dc:language>en-US</dc:language>
  <cp:lastModifiedBy>Dr. Radhakrishnan</cp:lastModifiedBy>
  <dcterms:modified xsi:type="dcterms:W3CDTF">2014-11-24T18:11:26Z</dcterms:modified>
  <cp:revision>1</cp:revision>
  <dc:subject/>
  <dc:title>Slide 1</dc:title>
</cp:coreProperties>
</file>